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" userDrawn="1">
          <p15:clr>
            <a:srgbClr val="A4A3A4"/>
          </p15:clr>
        </p15:guide>
        <p15:guide id="2" pos="336" userDrawn="1">
          <p15:clr>
            <a:srgbClr val="A4A3A4"/>
          </p15:clr>
        </p15:guide>
        <p15:guide id="3" pos="3984" userDrawn="1">
          <p15:clr>
            <a:srgbClr val="A4A3A4"/>
          </p15:clr>
        </p15:guide>
        <p15:guide id="4" pos="3696" userDrawn="1">
          <p15:clr>
            <a:srgbClr val="A4A3A4"/>
          </p15:clr>
        </p15:guide>
        <p15:guide id="5" orient="horz" pos="32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972" y="-1632"/>
      </p:cViewPr>
      <p:guideLst>
        <p:guide orient="horz" pos="264"/>
        <p:guide pos="336"/>
        <p:guide pos="3984"/>
        <p:guide pos="3696"/>
        <p:guide orient="horz" pos="32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475" cy="481046"/>
          </a:xfrm>
          <a:prstGeom prst="rect">
            <a:avLst/>
          </a:prstGeom>
        </p:spPr>
        <p:txBody>
          <a:bodyPr vert="horz" lIns="95079" tIns="47540" rIns="95079" bIns="4754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064" y="0"/>
            <a:ext cx="3170475" cy="481046"/>
          </a:xfrm>
          <a:prstGeom prst="rect">
            <a:avLst/>
          </a:prstGeom>
        </p:spPr>
        <p:txBody>
          <a:bodyPr vert="horz" lIns="95079" tIns="47540" rIns="95079" bIns="47540" rtlCol="0"/>
          <a:lstStyle>
            <a:lvl1pPr algn="r">
              <a:defRPr sz="1200"/>
            </a:lvl1pPr>
          </a:lstStyle>
          <a:p>
            <a:fld id="{82EBA9C4-7517-4B50-9DCC-DE4C3412DF8C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1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79" tIns="47540" rIns="95079" bIns="4754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003"/>
            <a:ext cx="5852160" cy="3781048"/>
          </a:xfrm>
          <a:prstGeom prst="rect">
            <a:avLst/>
          </a:prstGeom>
        </p:spPr>
        <p:txBody>
          <a:bodyPr vert="horz" lIns="95079" tIns="47540" rIns="95079" bIns="4754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56"/>
            <a:ext cx="3170475" cy="481045"/>
          </a:xfrm>
          <a:prstGeom prst="rect">
            <a:avLst/>
          </a:prstGeom>
        </p:spPr>
        <p:txBody>
          <a:bodyPr vert="horz" lIns="95079" tIns="47540" rIns="95079" bIns="4754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064" y="9120156"/>
            <a:ext cx="3170475" cy="481045"/>
          </a:xfrm>
          <a:prstGeom prst="rect">
            <a:avLst/>
          </a:prstGeom>
        </p:spPr>
        <p:txBody>
          <a:bodyPr vert="horz" lIns="95079" tIns="47540" rIns="95079" bIns="47540" rtlCol="0" anchor="b"/>
          <a:lstStyle>
            <a:lvl1pPr algn="r">
              <a:defRPr sz="1200"/>
            </a:lvl1pPr>
          </a:lstStyle>
          <a:p>
            <a:fld id="{90CF0F09-0DCB-44F2-97BD-3E0C1FA2DA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213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CF0F09-0DCB-44F2-97BD-3E0C1FA2DA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9818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83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55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27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47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70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595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70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94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25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19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23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F2F01-4441-42A0-85DD-18DC6052AECF}" type="datetimeFigureOut">
              <a:rPr lang="en-US" smtClean="0"/>
              <a:t>3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6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oleObject" Target="../embeddings/oleObject4.bin"/><Relationship Id="rId18" Type="http://schemas.openxmlformats.org/officeDocument/2006/relationships/image" Target="../media/image10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emf"/><Relationship Id="rId12" Type="http://schemas.openxmlformats.org/officeDocument/2006/relationships/image" Target="../media/image3.emf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oleObject" Target="../embeddings/oleObject3.bin"/><Relationship Id="rId5" Type="http://schemas.openxmlformats.org/officeDocument/2006/relationships/image" Target="../media/image7.emf"/><Relationship Id="rId15" Type="http://schemas.openxmlformats.org/officeDocument/2006/relationships/oleObject" Target="../embeddings/oleObject5.bin"/><Relationship Id="rId10" Type="http://schemas.openxmlformats.org/officeDocument/2006/relationships/image" Target="../media/image2.emf"/><Relationship Id="rId19" Type="http://schemas.openxmlformats.org/officeDocument/2006/relationships/image" Target="../media/image11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2.bin"/><Relationship Id="rId1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482" y="2723422"/>
            <a:ext cx="2394249" cy="226665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="" xmlns:a16="http://schemas.microsoft.com/office/drawing/2014/main" id="{E703370B-5363-364F-B1D3-B9D6B47A08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5747" y="487584"/>
            <a:ext cx="2159000" cy="2260600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8649599"/>
              </p:ext>
            </p:extLst>
          </p:nvPr>
        </p:nvGraphicFramePr>
        <p:xfrm>
          <a:off x="482697" y="4699099"/>
          <a:ext cx="2323561" cy="2259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4" name="Prism 8" r:id="rId6" imgW="2450003" imgH="2258936" progId="Prism8.Document">
                  <p:embed/>
                </p:oleObj>
              </mc:Choice>
              <mc:Fallback>
                <p:oleObj name="Prism 8" r:id="rId6" imgW="2450003" imgH="22589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2697" y="4699099"/>
                        <a:ext cx="2323561" cy="2259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3" name="TextBox 82"/>
          <p:cNvSpPr txBox="1"/>
          <p:nvPr/>
        </p:nvSpPr>
        <p:spPr>
          <a:xfrm>
            <a:off x="380482" y="37614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73019" y="503828"/>
            <a:ext cx="1359263" cy="213729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14263" y="8647135"/>
            <a:ext cx="63151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Parameters in maternal and fetal compartments.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LISA quantification in serum of pregnant females for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GFB2 (n=8 non parous, n=1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om</a:t>
            </a:r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p=0.0001)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GFB1 (n=1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om</a:t>
            </a:r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n=5 Mom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p=0.35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HC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Fcγ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E17.5 placental decidua. Scale bars=100µm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ultiplex ELISA on uterine fluid surrounding each fetus (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 and 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=5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Western blot quantification for expression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 fetal liver (n=6; p=0.005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HC staining of extra CNS tissue for CD31 expression in fetal brain (representative of n=3 fetuses from different mothers).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653115" y="3465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C2F550F8-6FC2-534F-AC7D-46A50FCBD362}"/>
              </a:ext>
            </a:extLst>
          </p:cNvPr>
          <p:cNvSpPr txBox="1"/>
          <p:nvPr/>
        </p:nvSpPr>
        <p:spPr>
          <a:xfrm>
            <a:off x="4665250" y="3465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C2F550F8-6FC2-534F-AC7D-46A50FCBD362}"/>
              </a:ext>
            </a:extLst>
          </p:cNvPr>
          <p:cNvSpPr txBox="1"/>
          <p:nvPr/>
        </p:nvSpPr>
        <p:spPr>
          <a:xfrm>
            <a:off x="474746" y="28082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C2F550F8-6FC2-534F-AC7D-46A50FCBD362}"/>
              </a:ext>
            </a:extLst>
          </p:cNvPr>
          <p:cNvSpPr txBox="1"/>
          <p:nvPr/>
        </p:nvSpPr>
        <p:spPr>
          <a:xfrm>
            <a:off x="500194" y="67467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22134"/>
              </p:ext>
            </p:extLst>
          </p:nvPr>
        </p:nvGraphicFramePr>
        <p:xfrm>
          <a:off x="2215701" y="2701143"/>
          <a:ext cx="2371608" cy="2212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5" name="Prism 8" r:id="rId9" imgW="2469811" imgH="2213210" progId="Prism8.Document">
                  <p:embed/>
                </p:oleObj>
              </mc:Choice>
              <mc:Fallback>
                <p:oleObj name="Prism 8" r:id="rId9" imgW="2469811" imgH="221321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215701" y="2701143"/>
                        <a:ext cx="2371608" cy="2212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9331747"/>
              </p:ext>
            </p:extLst>
          </p:nvPr>
        </p:nvGraphicFramePr>
        <p:xfrm>
          <a:off x="4231634" y="2679711"/>
          <a:ext cx="2297785" cy="2255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6" name="Prism 8" r:id="rId11" imgW="2329718" imgH="2255695" progId="Prism8.Document">
                  <p:embed/>
                </p:oleObj>
              </mc:Choice>
              <mc:Fallback>
                <p:oleObj name="Prism 8" r:id="rId11" imgW="2329718" imgH="225569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31634" y="2679711"/>
                        <a:ext cx="2297785" cy="2255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9731526"/>
              </p:ext>
            </p:extLst>
          </p:nvPr>
        </p:nvGraphicFramePr>
        <p:xfrm>
          <a:off x="2439112" y="4729603"/>
          <a:ext cx="2331400" cy="2211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7" name="Prism 8" r:id="rId13" imgW="2456126" imgH="2211770" progId="Prism8.Document">
                  <p:embed/>
                </p:oleObj>
              </mc:Choice>
              <mc:Fallback>
                <p:oleObj name="Prism 8" r:id="rId13" imgW="2456126" imgH="221177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439112" y="4729603"/>
                        <a:ext cx="2331400" cy="2211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2099224"/>
              </p:ext>
            </p:extLst>
          </p:nvPr>
        </p:nvGraphicFramePr>
        <p:xfrm>
          <a:off x="4255314" y="4706583"/>
          <a:ext cx="2312090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8" name="Prism 8" r:id="rId15" imgW="2443881" imgH="2257496" progId="Prism8.Document">
                  <p:embed/>
                </p:oleObj>
              </mc:Choice>
              <mc:Fallback>
                <p:oleObj name="Prism 8" r:id="rId15" imgW="2443881" imgH="225749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255314" y="4706583"/>
                        <a:ext cx="2312090" cy="225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Oval 12"/>
          <p:cNvSpPr>
            <a:spLocks noChangeAspect="1"/>
          </p:cNvSpPr>
          <p:nvPr/>
        </p:nvSpPr>
        <p:spPr>
          <a:xfrm>
            <a:off x="5692806" y="4619216"/>
            <a:ext cx="51435" cy="5143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740114" y="4665624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Fetus</a:t>
            </a:r>
            <a:r>
              <a:rPr lang="en-US" sz="7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733515" y="4544905"/>
            <a:ext cx="57579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etus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</a:t>
            </a:r>
          </a:p>
        </p:txBody>
      </p:sp>
      <p:sp>
        <p:nvSpPr>
          <p:cNvPr id="18" name="Isosceles Triangle 17"/>
          <p:cNvSpPr>
            <a:spLocks noChangeAspect="1"/>
          </p:cNvSpPr>
          <p:nvPr/>
        </p:nvSpPr>
        <p:spPr>
          <a:xfrm>
            <a:off x="5693429" y="4736696"/>
            <a:ext cx="66436" cy="68580"/>
          </a:xfrm>
          <a:prstGeom prst="triangle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3103573" y="6785691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01505" y="6939580"/>
            <a:ext cx="1866555" cy="135106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="" xmlns:a16="http://schemas.microsoft.com/office/drawing/2014/main" id="{68485D44-5C0D-1542-8316-D4D1E57594A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34323" y="6746729"/>
            <a:ext cx="2027178" cy="195775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5EE63642-2706-584F-B1F8-3E69DDF6BF7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59587" y="292100"/>
            <a:ext cx="2326645" cy="2568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0891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</TotalTime>
  <Words>132</Words>
  <Application>Microsoft Office PowerPoint</Application>
  <PresentationFormat>A4 Paper (210x297 mm)</PresentationFormat>
  <Paragraphs>1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ni, Ritika</dc:creator>
  <cp:lastModifiedBy>Jaini, Ritika</cp:lastModifiedBy>
  <cp:revision>86</cp:revision>
  <cp:lastPrinted>2021-03-11T19:42:04Z</cp:lastPrinted>
  <dcterms:created xsi:type="dcterms:W3CDTF">2020-08-14T21:01:00Z</dcterms:created>
  <dcterms:modified xsi:type="dcterms:W3CDTF">2021-03-11T19:42:25Z</dcterms:modified>
</cp:coreProperties>
</file>